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" userDrawn="1">
          <p15:clr>
            <a:srgbClr val="A4A3A4"/>
          </p15:clr>
        </p15:guide>
        <p15:guide id="2" pos="19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2184" y="58"/>
      </p:cViewPr>
      <p:guideLst>
        <p:guide orient="horz" pos="262"/>
        <p:guide pos="191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8907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31584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12536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2674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7373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59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3124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6879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1883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3933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5306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E6112-60D8-4E08-9D1D-6C513A847DDB}" type="datetimeFigureOut">
              <a:rPr lang="en-AU" smtClean="0"/>
              <a:t>3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0857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2840119" y="85622"/>
            <a:ext cx="2606175" cy="2271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grpSp>
        <p:nvGrpSpPr>
          <p:cNvPr id="2" name="Group 1"/>
          <p:cNvGrpSpPr/>
          <p:nvPr/>
        </p:nvGrpSpPr>
        <p:grpSpPr>
          <a:xfrm>
            <a:off x="733876" y="199221"/>
            <a:ext cx="4727868" cy="8424000"/>
            <a:chOff x="601512" y="79429"/>
            <a:chExt cx="4727868" cy="8976519"/>
          </a:xfrm>
        </p:grpSpPr>
        <p:grpSp>
          <p:nvGrpSpPr>
            <p:cNvPr id="9" name="Group 8"/>
            <p:cNvGrpSpPr/>
            <p:nvPr/>
          </p:nvGrpSpPr>
          <p:grpSpPr>
            <a:xfrm>
              <a:off x="601512" y="89904"/>
              <a:ext cx="2266052" cy="1390921"/>
              <a:chOff x="601512" y="153127"/>
              <a:chExt cx="2266052" cy="1264474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28" t="14773" r="7504" b="18713"/>
              <a:stretch/>
            </p:blipFill>
            <p:spPr>
              <a:xfrm>
                <a:off x="601512" y="332850"/>
                <a:ext cx="2266052" cy="1084751"/>
              </a:xfrm>
              <a:prstGeom prst="rect">
                <a:avLst/>
              </a:prstGeom>
            </p:spPr>
          </p:pic>
          <p:sp>
            <p:nvSpPr>
              <p:cNvPr id="54" name="TextBox 53"/>
              <p:cNvSpPr txBox="1"/>
              <p:nvPr/>
            </p:nvSpPr>
            <p:spPr>
              <a:xfrm>
                <a:off x="721076" y="153127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2</a:t>
                </a:r>
                <a:endParaRPr lang="en-AU" sz="1400" dirty="0"/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601512" y="1439427"/>
              <a:ext cx="2248235" cy="1421972"/>
              <a:chOff x="601512" y="1504062"/>
              <a:chExt cx="2248235" cy="1292702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18" t="14966" r="8415" b="18925"/>
              <a:stretch/>
            </p:blipFill>
            <p:spPr>
              <a:xfrm>
                <a:off x="601512" y="1708765"/>
                <a:ext cx="2248235" cy="1087999"/>
              </a:xfrm>
              <a:prstGeom prst="rect">
                <a:avLst/>
              </a:prstGeom>
            </p:spPr>
          </p:pic>
          <p:sp>
            <p:nvSpPr>
              <p:cNvPr id="55" name="TextBox 54"/>
              <p:cNvSpPr txBox="1"/>
              <p:nvPr/>
            </p:nvSpPr>
            <p:spPr>
              <a:xfrm>
                <a:off x="716260" y="1504062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3</a:t>
                </a:r>
                <a:endParaRPr lang="en-AU" sz="1400" dirty="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636880" y="2976579"/>
              <a:ext cx="2141106" cy="1436664"/>
              <a:chOff x="636880" y="3041882"/>
              <a:chExt cx="2141106" cy="1306058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06" t="17852" r="11938" b="19169"/>
              <a:stretch/>
            </p:blipFill>
            <p:spPr>
              <a:xfrm>
                <a:off x="636880" y="3297975"/>
                <a:ext cx="2141106" cy="1049965"/>
              </a:xfrm>
              <a:prstGeom prst="rect">
                <a:avLst/>
              </a:prstGeom>
            </p:spPr>
          </p:pic>
          <p:sp>
            <p:nvSpPr>
              <p:cNvPr id="56" name="TextBox 55"/>
              <p:cNvSpPr txBox="1"/>
              <p:nvPr/>
            </p:nvSpPr>
            <p:spPr>
              <a:xfrm>
                <a:off x="716260" y="3041882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4</a:t>
                </a:r>
                <a:endParaRPr lang="en-AU" sz="1400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663316" y="4620717"/>
              <a:ext cx="2195514" cy="1458784"/>
              <a:chOff x="663316" y="4687026"/>
              <a:chExt cx="2195514" cy="1326167"/>
            </a:xfrm>
          </p:grpSpPr>
          <p:pic>
            <p:nvPicPr>
              <p:cNvPr id="38" name="Picture 37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00" t="17524" r="9739" b="18574"/>
              <a:stretch/>
            </p:blipFill>
            <p:spPr>
              <a:xfrm>
                <a:off x="663316" y="4955174"/>
                <a:ext cx="2195514" cy="1058019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771108" y="4687026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5</a:t>
                </a:r>
                <a:endParaRPr lang="en-AU" sz="1400" dirty="0"/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709201" y="6227195"/>
              <a:ext cx="2140546" cy="1433955"/>
              <a:chOff x="709201" y="6292375"/>
              <a:chExt cx="2140546" cy="1303595"/>
            </a:xfrm>
          </p:grpSpPr>
          <p:pic>
            <p:nvPicPr>
              <p:cNvPr id="39" name="Content Placeholder 3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93" t="17668" r="10925" b="19078"/>
              <a:stretch/>
            </p:blipFill>
            <p:spPr>
              <a:xfrm>
                <a:off x="709201" y="6552861"/>
                <a:ext cx="2140546" cy="1043109"/>
              </a:xfrm>
              <a:prstGeom prst="rect">
                <a:avLst/>
              </a:prstGeom>
            </p:spPr>
          </p:pic>
          <p:sp>
            <p:nvSpPr>
              <p:cNvPr id="58" name="TextBox 57"/>
              <p:cNvSpPr txBox="1"/>
              <p:nvPr/>
            </p:nvSpPr>
            <p:spPr>
              <a:xfrm>
                <a:off x="804674" y="6292375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6</a:t>
                </a:r>
                <a:endParaRPr lang="en-AU" sz="1400" dirty="0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709201" y="7625728"/>
              <a:ext cx="2130918" cy="1430220"/>
              <a:chOff x="709201" y="7690738"/>
              <a:chExt cx="2130918" cy="1300200"/>
            </a:xfrm>
          </p:grpSpPr>
          <p:pic>
            <p:nvPicPr>
              <p:cNvPr id="40" name="Picture 3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96" t="18238" r="11526" b="18783"/>
              <a:stretch/>
            </p:blipFill>
            <p:spPr>
              <a:xfrm>
                <a:off x="709201" y="7946268"/>
                <a:ext cx="2130918" cy="1044670"/>
              </a:xfrm>
              <a:prstGeom prst="rect">
                <a:avLst/>
              </a:prstGeom>
            </p:spPr>
          </p:pic>
          <p:sp>
            <p:nvSpPr>
              <p:cNvPr id="59" name="TextBox 58"/>
              <p:cNvSpPr txBox="1"/>
              <p:nvPr/>
            </p:nvSpPr>
            <p:spPr>
              <a:xfrm>
                <a:off x="772640" y="7690738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7</a:t>
                </a:r>
                <a:endParaRPr lang="en-AU" sz="1400" dirty="0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3051582" y="79429"/>
              <a:ext cx="2203675" cy="1411760"/>
              <a:chOff x="3051582" y="141313"/>
              <a:chExt cx="2203675" cy="1283418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49" t="16883" r="8875" b="18518"/>
              <a:stretch/>
            </p:blipFill>
            <p:spPr>
              <a:xfrm>
                <a:off x="3051582" y="369938"/>
                <a:ext cx="2203675" cy="1054793"/>
              </a:xfrm>
              <a:prstGeom prst="rect">
                <a:avLst/>
              </a:prstGeom>
            </p:spPr>
          </p:pic>
          <p:sp>
            <p:nvSpPr>
              <p:cNvPr id="60" name="TextBox 59"/>
              <p:cNvSpPr txBox="1"/>
              <p:nvPr/>
            </p:nvSpPr>
            <p:spPr>
              <a:xfrm>
                <a:off x="3130170" y="141313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8</a:t>
                </a:r>
                <a:endParaRPr lang="en-AU" sz="1400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3074770" y="1434354"/>
              <a:ext cx="2132166" cy="1401593"/>
              <a:chOff x="3074770" y="1498063"/>
              <a:chExt cx="2132166" cy="1274175"/>
            </a:xfrm>
          </p:grpSpPr>
          <p:pic>
            <p:nvPicPr>
              <p:cNvPr id="42" name="Picture 41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52" t="18537" r="11733" b="20550"/>
              <a:stretch/>
            </p:blipFill>
            <p:spPr>
              <a:xfrm>
                <a:off x="3074770" y="1763045"/>
                <a:ext cx="2132166" cy="100919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</p:pic>
          <p:sp>
            <p:nvSpPr>
              <p:cNvPr id="61" name="TextBox 60"/>
              <p:cNvSpPr txBox="1"/>
              <p:nvPr/>
            </p:nvSpPr>
            <p:spPr>
              <a:xfrm>
                <a:off x="3178812" y="1498063"/>
                <a:ext cx="4587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9</a:t>
                </a:r>
                <a:endParaRPr lang="en-AU" sz="1400" dirty="0"/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074770" y="2965128"/>
              <a:ext cx="2180487" cy="1458498"/>
              <a:chOff x="3107051" y="3076484"/>
              <a:chExt cx="2148206" cy="1282528"/>
            </a:xfrm>
          </p:grpSpPr>
          <p:pic>
            <p:nvPicPr>
              <p:cNvPr id="43" name="Content Placeholder 3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39" t="16808" r="10646" b="18805"/>
              <a:stretch/>
            </p:blipFill>
            <p:spPr>
              <a:xfrm>
                <a:off x="3107051" y="3297976"/>
                <a:ext cx="2148206" cy="1061036"/>
              </a:xfrm>
              <a:prstGeom prst="rect">
                <a:avLst/>
              </a:prstGeom>
            </p:spPr>
          </p:pic>
          <p:sp>
            <p:nvSpPr>
              <p:cNvPr id="62" name="TextBox 61"/>
              <p:cNvSpPr txBox="1"/>
              <p:nvPr/>
            </p:nvSpPr>
            <p:spPr>
              <a:xfrm>
                <a:off x="3209553" y="3076484"/>
                <a:ext cx="5501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10</a:t>
                </a:r>
                <a:endParaRPr lang="en-AU" sz="1400" dirty="0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083797" y="4618055"/>
              <a:ext cx="2245583" cy="1462318"/>
              <a:chOff x="3083797" y="4683814"/>
              <a:chExt cx="2245583" cy="1329380"/>
            </a:xfrm>
          </p:grpSpPr>
          <p:pic>
            <p:nvPicPr>
              <p:cNvPr id="44" name="Picture 43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39" t="16444" r="9325" b="19024"/>
              <a:stretch/>
            </p:blipFill>
            <p:spPr>
              <a:xfrm>
                <a:off x="3083797" y="4922766"/>
                <a:ext cx="2245583" cy="1090428"/>
              </a:xfrm>
              <a:prstGeom prst="rect">
                <a:avLst/>
              </a:prstGeom>
            </p:spPr>
          </p:pic>
          <p:sp>
            <p:nvSpPr>
              <p:cNvPr id="63" name="TextBox 62"/>
              <p:cNvSpPr txBox="1"/>
              <p:nvPr/>
            </p:nvSpPr>
            <p:spPr>
              <a:xfrm>
                <a:off x="3206047" y="4683814"/>
                <a:ext cx="5501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11</a:t>
                </a:r>
                <a:endParaRPr lang="en-AU" sz="1400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117364" y="6198852"/>
              <a:ext cx="2194650" cy="1484757"/>
              <a:chOff x="3130102" y="6270344"/>
              <a:chExt cx="2205865" cy="1327741"/>
            </a:xfrm>
          </p:grpSpPr>
          <p:pic>
            <p:nvPicPr>
              <p:cNvPr id="45" name="Picture 44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25" t="16076" r="10762" b="19307"/>
              <a:stretch/>
            </p:blipFill>
            <p:spPr>
              <a:xfrm>
                <a:off x="3130102" y="6497566"/>
                <a:ext cx="2205865" cy="1100519"/>
              </a:xfrm>
              <a:prstGeom prst="rect">
                <a:avLst/>
              </a:prstGeom>
            </p:spPr>
          </p:pic>
          <p:sp>
            <p:nvSpPr>
              <p:cNvPr id="64" name="TextBox 63"/>
              <p:cNvSpPr txBox="1"/>
              <p:nvPr/>
            </p:nvSpPr>
            <p:spPr>
              <a:xfrm>
                <a:off x="3242030" y="6270344"/>
                <a:ext cx="5501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400" dirty="0" smtClean="0"/>
                  <a:t>K=12</a:t>
                </a:r>
                <a:endParaRPr lang="en-AU" sz="1400" dirty="0"/>
              </a:p>
            </p:txBody>
          </p:sp>
        </p:grpSp>
      </p:grpSp>
      <p:sp>
        <p:nvSpPr>
          <p:cNvPr id="65" name="TextBox 64"/>
          <p:cNvSpPr txBox="1"/>
          <p:nvPr/>
        </p:nvSpPr>
        <p:spPr>
          <a:xfrm>
            <a:off x="388072" y="8993261"/>
            <a:ext cx="622746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AU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</a:t>
            </a:r>
            <a:r>
              <a:rPr lang="en-AU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pulation stratification among 142 wild accessions of narrow-leafed lupin using </a:t>
            </a:r>
            <a:r>
              <a:rPr lang="en-AU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stSTRUCTURE</a:t>
            </a:r>
            <a:r>
              <a:rPr lang="en-AU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or K=2 – 12. Each colour denotes a population affiliation. Note that colours are not equivalent between panels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550988" y="186327"/>
            <a:ext cx="20512" cy="83316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3026877" y="251787"/>
            <a:ext cx="24247" cy="827201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5584275" y="267499"/>
            <a:ext cx="543" cy="813431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16649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</TotalTime>
  <Words>45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sa Mousaviderazmahalleh</dc:creator>
  <cp:lastModifiedBy>Mahsa Mousaviderazmahalleh</cp:lastModifiedBy>
  <cp:revision>35</cp:revision>
  <dcterms:created xsi:type="dcterms:W3CDTF">2016-11-04T04:41:02Z</dcterms:created>
  <dcterms:modified xsi:type="dcterms:W3CDTF">2017-11-03T09:42:02Z</dcterms:modified>
</cp:coreProperties>
</file>